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566284A-CB87-42DB-9695-19762DF3E553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4C178D9-BC0D-49B6-9F75-83B542E41E50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1830D06-9CE2-4F3C-AE6C-DD733F6E4058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1CF946D-4BBD-4C8E-8910-351CEAF12F7E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2734439-5DA4-486B-A77E-29B559981F0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2DA49C7-C69E-4113-B36D-1433C048B045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0900ED0-3889-4F47-A81C-B81ADE3DB58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ABEC049-901D-4B34-9E5A-D7819C80468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A0A7B2E-B77D-456E-B747-A789EC3434E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B6219E5-873F-4F7D-BA6E-2E5B07843F2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76A10B8-B322-4C50-BC9A-0178AFFDAA0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44B0F70-88FE-4D6F-8FB4-D546782AAA6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1E212491-2328-4891-B4F6-AFA460CE60E7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2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1248120" y="5445000"/>
            <a:ext cx="110556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ahoma"/>
              </a:rPr>
              <a:t>non-smoking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"/>
          <p:cNvSpPr/>
          <p:nvPr/>
        </p:nvSpPr>
        <p:spPr>
          <a:xfrm>
            <a:off x="2436480" y="5445000"/>
            <a:ext cx="72000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ahoma"/>
              </a:rPr>
              <a:t>smoking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"/>
          <p:cNvSpPr/>
          <p:nvPr/>
        </p:nvSpPr>
        <p:spPr>
          <a:xfrm>
            <a:off x="3334320" y="5445000"/>
            <a:ext cx="110556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ahoma"/>
              </a:rPr>
              <a:t>non-smoking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"/>
          <p:cNvSpPr/>
          <p:nvPr/>
        </p:nvSpPr>
        <p:spPr>
          <a:xfrm>
            <a:off x="4552560" y="5445000"/>
            <a:ext cx="72000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ahoma"/>
              </a:rPr>
              <a:t>smoking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"/>
          <p:cNvSpPr/>
          <p:nvPr/>
        </p:nvSpPr>
        <p:spPr>
          <a:xfrm>
            <a:off x="5429880" y="5445000"/>
            <a:ext cx="110556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ahoma"/>
              </a:rPr>
              <a:t>non-smoking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"/>
          <p:cNvSpPr/>
          <p:nvPr/>
        </p:nvSpPr>
        <p:spPr>
          <a:xfrm>
            <a:off x="6617880" y="5445000"/>
            <a:ext cx="72000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ahoma"/>
              </a:rPr>
              <a:t>smoking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"/>
          <p:cNvSpPr/>
          <p:nvPr/>
        </p:nvSpPr>
        <p:spPr>
          <a:xfrm>
            <a:off x="7425720" y="5445000"/>
            <a:ext cx="113148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ahoma"/>
              </a:rPr>
              <a:t>Non-smoking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"/>
          <p:cNvSpPr/>
          <p:nvPr/>
        </p:nvSpPr>
        <p:spPr>
          <a:xfrm rot="16200000">
            <a:off x="-756720" y="2940840"/>
            <a:ext cx="2715120" cy="305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Tahoma"/>
              </a:rPr>
              <a:t>Total IgG level (mg/ml)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"/>
          <p:cNvSpPr/>
          <p:nvPr/>
        </p:nvSpPr>
        <p:spPr>
          <a:xfrm>
            <a:off x="1182600" y="1050840"/>
            <a:ext cx="7304040" cy="4319640"/>
          </a:xfrm>
          <a:prstGeom prst="rect">
            <a:avLst/>
          </a:prstGeom>
          <a:noFill/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"/>
          <p:cNvSpPr/>
          <p:nvPr/>
        </p:nvSpPr>
        <p:spPr>
          <a:xfrm>
            <a:off x="874080" y="4049640"/>
            <a:ext cx="20484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ahoma"/>
              </a:rPr>
              <a:t>1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"/>
          <p:cNvSpPr/>
          <p:nvPr/>
        </p:nvSpPr>
        <p:spPr>
          <a:xfrm>
            <a:off x="874080" y="1335240"/>
            <a:ext cx="20484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ahoma"/>
              </a:rPr>
              <a:t>2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"/>
          <p:cNvSpPr/>
          <p:nvPr/>
        </p:nvSpPr>
        <p:spPr>
          <a:xfrm>
            <a:off x="1724040" y="2421000"/>
            <a:ext cx="152280" cy="1960560"/>
          </a:xfrm>
          <a:prstGeom prst="rect">
            <a:avLst/>
          </a:prstGeom>
          <a:solidFill>
            <a:srgbClr val="ffffff"/>
          </a:solidFill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"/>
          <p:cNvSpPr/>
          <p:nvPr/>
        </p:nvSpPr>
        <p:spPr>
          <a:xfrm>
            <a:off x="1674720" y="3402000"/>
            <a:ext cx="25236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"/>
          <p:cNvSpPr/>
          <p:nvPr/>
        </p:nvSpPr>
        <p:spPr>
          <a:xfrm>
            <a:off x="2719440" y="3359160"/>
            <a:ext cx="152280" cy="1293840"/>
          </a:xfrm>
          <a:prstGeom prst="rect">
            <a:avLst/>
          </a:prstGeom>
          <a:solidFill>
            <a:srgbClr val="ffffff"/>
          </a:solidFill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"/>
          <p:cNvSpPr/>
          <p:nvPr/>
        </p:nvSpPr>
        <p:spPr>
          <a:xfrm>
            <a:off x="2670120" y="4006800"/>
            <a:ext cx="25236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"/>
          <p:cNvSpPr/>
          <p:nvPr/>
        </p:nvSpPr>
        <p:spPr>
          <a:xfrm>
            <a:off x="3809880" y="2844720"/>
            <a:ext cx="152640" cy="1727280"/>
          </a:xfrm>
          <a:prstGeom prst="rect">
            <a:avLst/>
          </a:prstGeom>
          <a:solidFill>
            <a:srgbClr val="ffffff"/>
          </a:solidFill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"/>
          <p:cNvSpPr/>
          <p:nvPr/>
        </p:nvSpPr>
        <p:spPr>
          <a:xfrm>
            <a:off x="3760920" y="3708360"/>
            <a:ext cx="25236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"/>
          <p:cNvSpPr/>
          <p:nvPr/>
        </p:nvSpPr>
        <p:spPr>
          <a:xfrm>
            <a:off x="4835520" y="3643200"/>
            <a:ext cx="152280" cy="1220760"/>
          </a:xfrm>
          <a:prstGeom prst="rect">
            <a:avLst/>
          </a:prstGeom>
          <a:solidFill>
            <a:srgbClr val="ffffff"/>
          </a:solidFill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"/>
          <p:cNvSpPr/>
          <p:nvPr/>
        </p:nvSpPr>
        <p:spPr>
          <a:xfrm>
            <a:off x="4786200" y="4253040"/>
            <a:ext cx="25236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"/>
          <p:cNvSpPr/>
          <p:nvPr/>
        </p:nvSpPr>
        <p:spPr>
          <a:xfrm>
            <a:off x="5907240" y="3322800"/>
            <a:ext cx="152280" cy="1714320"/>
          </a:xfrm>
          <a:prstGeom prst="rect">
            <a:avLst/>
          </a:prstGeom>
          <a:solidFill>
            <a:srgbClr val="ffffff"/>
          </a:solidFill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"/>
          <p:cNvSpPr/>
          <p:nvPr/>
        </p:nvSpPr>
        <p:spPr>
          <a:xfrm>
            <a:off x="5856120" y="4179960"/>
            <a:ext cx="25272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"/>
          <p:cNvSpPr/>
          <p:nvPr/>
        </p:nvSpPr>
        <p:spPr>
          <a:xfrm>
            <a:off x="6902280" y="3632040"/>
            <a:ext cx="152640" cy="1514520"/>
          </a:xfrm>
          <a:prstGeom prst="rect">
            <a:avLst/>
          </a:prstGeom>
          <a:solidFill>
            <a:srgbClr val="ffffff"/>
          </a:solidFill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"/>
          <p:cNvSpPr/>
          <p:nvPr/>
        </p:nvSpPr>
        <p:spPr>
          <a:xfrm>
            <a:off x="6851520" y="4387680"/>
            <a:ext cx="25272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"/>
          <p:cNvSpPr/>
          <p:nvPr/>
        </p:nvSpPr>
        <p:spPr>
          <a:xfrm>
            <a:off x="7905600" y="1701720"/>
            <a:ext cx="152640" cy="2217960"/>
          </a:xfrm>
          <a:prstGeom prst="rect">
            <a:avLst/>
          </a:prstGeom>
          <a:solidFill>
            <a:srgbClr val="ffffff"/>
          </a:solidFill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"/>
          <p:cNvSpPr/>
          <p:nvPr/>
        </p:nvSpPr>
        <p:spPr>
          <a:xfrm>
            <a:off x="7856640" y="2816280"/>
            <a:ext cx="25236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66" name=""/>
          <p:cNvGrpSpPr/>
          <p:nvPr/>
        </p:nvGrpSpPr>
        <p:grpSpPr>
          <a:xfrm>
            <a:off x="1077840" y="5200560"/>
            <a:ext cx="204840" cy="144360"/>
            <a:chOff x="1077840" y="5200560"/>
            <a:chExt cx="204840" cy="144360"/>
          </a:xfrm>
        </p:grpSpPr>
        <p:sp>
          <p:nvSpPr>
            <p:cNvPr id="67" name=""/>
            <p:cNvSpPr/>
            <p:nvPr/>
          </p:nvSpPr>
          <p:spPr>
            <a:xfrm>
              <a:off x="1108080" y="5236920"/>
              <a:ext cx="144360" cy="71640"/>
            </a:xfrm>
            <a:custGeom>
              <a:avLst/>
              <a:gdLst>
                <a:gd name="textAreaLeft" fmla="*/ 0 w 144360"/>
                <a:gd name="textAreaRight" fmla="*/ 144360 w 144360"/>
                <a:gd name="textAreaTop" fmla="*/ 9000 h 71640"/>
                <a:gd name="textAreaBottom" fmla="*/ 62640 h 71640"/>
              </a:gdLst>
              <a:ahLst/>
              <a:rect l="textAreaLeft" t="textAreaTop" r="textAreaRight" b="textAreaBottom"/>
              <a:pathLst>
                <a:path w="21600" h="21600">
                  <a:moveTo>
                    <a:pt x="0" y="1400"/>
                  </a:moveTo>
                  <a:cubicBezTo>
                    <a:pt x="7200" y="-3560"/>
                    <a:pt x="14400" y="6360"/>
                    <a:pt x="21600" y="1400"/>
                  </a:cubicBezTo>
                  <a:lnTo>
                    <a:pt x="21600" y="20200"/>
                  </a:lnTo>
                  <a:cubicBezTo>
                    <a:pt x="14400" y="25160"/>
                    <a:pt x="7200" y="15240"/>
                    <a:pt x="0" y="20200"/>
                  </a:cubicBezTo>
                  <a:close/>
                </a:path>
              </a:pathLst>
            </a:cu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6840" bIns="684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" name=""/>
            <p:cNvSpPr/>
            <p:nvPr/>
          </p:nvSpPr>
          <p:spPr>
            <a:xfrm>
              <a:off x="1077840" y="5200560"/>
              <a:ext cx="0" cy="144360"/>
            </a:xfrm>
            <a:prstGeom prst="line">
              <a:avLst/>
            </a:prstGeom>
            <a:ln w="7632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" name=""/>
            <p:cNvSpPr/>
            <p:nvPr/>
          </p:nvSpPr>
          <p:spPr>
            <a:xfrm>
              <a:off x="1282680" y="5200560"/>
              <a:ext cx="0" cy="144360"/>
            </a:xfrm>
            <a:prstGeom prst="line">
              <a:avLst/>
            </a:prstGeom>
            <a:ln w="7632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70" name=""/>
          <p:cNvGrpSpPr/>
          <p:nvPr/>
        </p:nvGrpSpPr>
        <p:grpSpPr>
          <a:xfrm>
            <a:off x="8383680" y="5200560"/>
            <a:ext cx="204840" cy="144360"/>
            <a:chOff x="8383680" y="5200560"/>
            <a:chExt cx="204840" cy="144360"/>
          </a:xfrm>
        </p:grpSpPr>
        <p:sp>
          <p:nvSpPr>
            <p:cNvPr id="71" name=""/>
            <p:cNvSpPr/>
            <p:nvPr/>
          </p:nvSpPr>
          <p:spPr>
            <a:xfrm>
              <a:off x="8413920" y="5236920"/>
              <a:ext cx="144360" cy="71640"/>
            </a:xfrm>
            <a:custGeom>
              <a:avLst/>
              <a:gdLst>
                <a:gd name="textAreaLeft" fmla="*/ 0 w 144360"/>
                <a:gd name="textAreaRight" fmla="*/ 144360 w 144360"/>
                <a:gd name="textAreaTop" fmla="*/ 9000 h 71640"/>
                <a:gd name="textAreaBottom" fmla="*/ 62640 h 71640"/>
              </a:gdLst>
              <a:ahLst/>
              <a:rect l="textAreaLeft" t="textAreaTop" r="textAreaRight" b="textAreaBottom"/>
              <a:pathLst>
                <a:path w="21600" h="21600">
                  <a:moveTo>
                    <a:pt x="0" y="1400"/>
                  </a:moveTo>
                  <a:cubicBezTo>
                    <a:pt x="7200" y="-3560"/>
                    <a:pt x="14400" y="6360"/>
                    <a:pt x="21600" y="1400"/>
                  </a:cubicBezTo>
                  <a:lnTo>
                    <a:pt x="21600" y="20200"/>
                  </a:lnTo>
                  <a:cubicBezTo>
                    <a:pt x="14400" y="25160"/>
                    <a:pt x="7200" y="15240"/>
                    <a:pt x="0" y="20200"/>
                  </a:cubicBezTo>
                  <a:close/>
                </a:path>
              </a:pathLst>
            </a:cu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6840" bIns="684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2" name=""/>
            <p:cNvSpPr/>
            <p:nvPr/>
          </p:nvSpPr>
          <p:spPr>
            <a:xfrm>
              <a:off x="8383680" y="5200560"/>
              <a:ext cx="0" cy="144360"/>
            </a:xfrm>
            <a:prstGeom prst="line">
              <a:avLst/>
            </a:prstGeom>
            <a:ln w="7632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3" name=""/>
            <p:cNvSpPr/>
            <p:nvPr/>
          </p:nvSpPr>
          <p:spPr>
            <a:xfrm>
              <a:off x="8588520" y="5200560"/>
              <a:ext cx="0" cy="144360"/>
            </a:xfrm>
            <a:prstGeom prst="line">
              <a:avLst/>
            </a:prstGeom>
            <a:ln w="7632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74" name=""/>
          <p:cNvSpPr/>
          <p:nvPr/>
        </p:nvSpPr>
        <p:spPr>
          <a:xfrm>
            <a:off x="3241800" y="5286240"/>
            <a:ext cx="0" cy="8280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36000" bIns="36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"/>
          <p:cNvSpPr/>
          <p:nvPr/>
        </p:nvSpPr>
        <p:spPr>
          <a:xfrm>
            <a:off x="5392800" y="5286240"/>
            <a:ext cx="0" cy="8280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36000" bIns="36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"/>
          <p:cNvSpPr/>
          <p:nvPr/>
        </p:nvSpPr>
        <p:spPr>
          <a:xfrm>
            <a:off x="7477200" y="5286240"/>
            <a:ext cx="0" cy="8280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36000" bIns="36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" name=""/>
          <p:cNvSpPr/>
          <p:nvPr/>
        </p:nvSpPr>
        <p:spPr>
          <a:xfrm>
            <a:off x="1189080" y="5748480"/>
            <a:ext cx="201132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" name=""/>
          <p:cNvSpPr/>
          <p:nvPr/>
        </p:nvSpPr>
        <p:spPr>
          <a:xfrm>
            <a:off x="3317760" y="5748480"/>
            <a:ext cx="201132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" name=""/>
          <p:cNvSpPr/>
          <p:nvPr/>
        </p:nvSpPr>
        <p:spPr>
          <a:xfrm>
            <a:off x="5450040" y="5748480"/>
            <a:ext cx="201132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" name=""/>
          <p:cNvSpPr/>
          <p:nvPr/>
        </p:nvSpPr>
        <p:spPr>
          <a:xfrm>
            <a:off x="7570800" y="5748480"/>
            <a:ext cx="82224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" name=""/>
          <p:cNvSpPr/>
          <p:nvPr/>
        </p:nvSpPr>
        <p:spPr>
          <a:xfrm>
            <a:off x="1182600" y="4726080"/>
            <a:ext cx="5076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" name=""/>
          <p:cNvSpPr/>
          <p:nvPr/>
        </p:nvSpPr>
        <p:spPr>
          <a:xfrm>
            <a:off x="1182600" y="4181400"/>
            <a:ext cx="5076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" name=""/>
          <p:cNvSpPr/>
          <p:nvPr/>
        </p:nvSpPr>
        <p:spPr>
          <a:xfrm>
            <a:off x="1182600" y="3637080"/>
            <a:ext cx="5076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" name=""/>
          <p:cNvSpPr/>
          <p:nvPr/>
        </p:nvSpPr>
        <p:spPr>
          <a:xfrm>
            <a:off x="1182600" y="1460520"/>
            <a:ext cx="5076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" name=""/>
          <p:cNvSpPr/>
          <p:nvPr/>
        </p:nvSpPr>
        <p:spPr>
          <a:xfrm>
            <a:off x="1182600" y="2003400"/>
            <a:ext cx="5076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" name=""/>
          <p:cNvSpPr/>
          <p:nvPr/>
        </p:nvSpPr>
        <p:spPr>
          <a:xfrm>
            <a:off x="1182600" y="2548080"/>
            <a:ext cx="5076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7" name=""/>
          <p:cNvSpPr/>
          <p:nvPr/>
        </p:nvSpPr>
        <p:spPr>
          <a:xfrm>
            <a:off x="1182600" y="3092400"/>
            <a:ext cx="5076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8" name=""/>
          <p:cNvSpPr/>
          <p:nvPr/>
        </p:nvSpPr>
        <p:spPr>
          <a:xfrm>
            <a:off x="959040" y="5170320"/>
            <a:ext cx="10296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ahoma"/>
              </a:rPr>
              <a:t>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9" name=""/>
          <p:cNvSpPr/>
          <p:nvPr/>
        </p:nvSpPr>
        <p:spPr>
          <a:xfrm>
            <a:off x="1404000" y="5767560"/>
            <a:ext cx="1581120" cy="48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Tahoma"/>
              </a:rPr>
              <a:t>HLA-DQB1*0602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Tahoma"/>
              </a:rPr>
              <a:t>negative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0" name=""/>
          <p:cNvSpPr/>
          <p:nvPr/>
        </p:nvSpPr>
        <p:spPr>
          <a:xfrm>
            <a:off x="5772240" y="6045120"/>
            <a:ext cx="1364760" cy="48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Tahoma"/>
              </a:rPr>
              <a:t>Narcolepsy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Tahoma"/>
              </a:rPr>
              <a:t>with cataplexy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1" name=""/>
          <p:cNvSpPr/>
          <p:nvPr/>
        </p:nvSpPr>
        <p:spPr>
          <a:xfrm>
            <a:off x="7356960" y="6045120"/>
            <a:ext cx="1252080" cy="48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Tahoma"/>
              </a:rPr>
              <a:t>Idiopathic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Tahoma"/>
              </a:rPr>
              <a:t>hypersomnia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2" name=""/>
          <p:cNvSpPr/>
          <p:nvPr/>
        </p:nvSpPr>
        <p:spPr>
          <a:xfrm>
            <a:off x="3533040" y="5770440"/>
            <a:ext cx="1581120" cy="48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Tahoma"/>
              </a:rPr>
              <a:t>HLA-DQB1*0602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Tahoma"/>
              </a:rPr>
              <a:t>positive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3" name=""/>
          <p:cNvSpPr/>
          <p:nvPr/>
        </p:nvSpPr>
        <p:spPr>
          <a:xfrm>
            <a:off x="2277720" y="6305400"/>
            <a:ext cx="1559880" cy="243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Tahoma"/>
              </a:rPr>
              <a:t>Healthy controls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4" name=""/>
          <p:cNvSpPr/>
          <p:nvPr/>
        </p:nvSpPr>
        <p:spPr>
          <a:xfrm>
            <a:off x="1198440" y="6289560"/>
            <a:ext cx="413244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5" name=""/>
          <p:cNvSpPr/>
          <p:nvPr/>
        </p:nvSpPr>
        <p:spPr>
          <a:xfrm>
            <a:off x="1543680" y="5164200"/>
            <a:ext cx="51588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ahoma"/>
              </a:rPr>
              <a:t>37(12)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6" name=""/>
          <p:cNvSpPr/>
          <p:nvPr/>
        </p:nvSpPr>
        <p:spPr>
          <a:xfrm>
            <a:off x="2581560" y="5164200"/>
            <a:ext cx="41364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ahoma"/>
              </a:rPr>
              <a:t>27(9)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7" name=""/>
          <p:cNvSpPr/>
          <p:nvPr/>
        </p:nvSpPr>
        <p:spPr>
          <a:xfrm>
            <a:off x="3621960" y="5164200"/>
            <a:ext cx="51588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ahoma"/>
              </a:rPr>
              <a:t>31(21)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8" name=""/>
          <p:cNvSpPr/>
          <p:nvPr/>
        </p:nvSpPr>
        <p:spPr>
          <a:xfrm>
            <a:off x="4697640" y="5164200"/>
            <a:ext cx="41364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ahoma"/>
              </a:rPr>
              <a:t>11(3)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9" name=""/>
          <p:cNvSpPr/>
          <p:nvPr/>
        </p:nvSpPr>
        <p:spPr>
          <a:xfrm>
            <a:off x="5717520" y="5164200"/>
            <a:ext cx="51588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ahoma"/>
              </a:rPr>
              <a:t>54(29)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0" name=""/>
          <p:cNvSpPr/>
          <p:nvPr/>
        </p:nvSpPr>
        <p:spPr>
          <a:xfrm>
            <a:off x="6774120" y="5164200"/>
            <a:ext cx="41364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ahoma"/>
              </a:rPr>
              <a:t>45(5)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1" name=""/>
          <p:cNvSpPr/>
          <p:nvPr/>
        </p:nvSpPr>
        <p:spPr>
          <a:xfrm>
            <a:off x="7719120" y="5164200"/>
            <a:ext cx="51588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ahoma"/>
              </a:rPr>
              <a:t>17(11)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2" name=""/>
          <p:cNvSpPr/>
          <p:nvPr/>
        </p:nvSpPr>
        <p:spPr>
          <a:xfrm>
            <a:off x="2639520" y="2897280"/>
            <a:ext cx="3070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ahoma"/>
              </a:rPr>
              <a:t>*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3" name=""/>
          <p:cNvSpPr/>
          <p:nvPr/>
        </p:nvSpPr>
        <p:spPr>
          <a:xfrm>
            <a:off x="4758840" y="3228840"/>
            <a:ext cx="3070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ahoma"/>
              </a:rPr>
              <a:t>*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4" name=""/>
          <p:cNvSpPr/>
          <p:nvPr/>
        </p:nvSpPr>
        <p:spPr>
          <a:xfrm>
            <a:off x="5822280" y="2900520"/>
            <a:ext cx="3070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ahoma"/>
              </a:rPr>
              <a:t>*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5" name=""/>
          <p:cNvSpPr/>
          <p:nvPr/>
        </p:nvSpPr>
        <p:spPr>
          <a:xfrm>
            <a:off x="6838560" y="3214800"/>
            <a:ext cx="3070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ahoma"/>
              </a:rPr>
              <a:t>*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6" name=""/>
          <p:cNvSpPr/>
          <p:nvPr/>
        </p:nvSpPr>
        <p:spPr>
          <a:xfrm>
            <a:off x="4507920" y="1154160"/>
            <a:ext cx="75816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ahoma"/>
              </a:rPr>
              <a:t>P = 0.059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7" name=""/>
          <p:cNvSpPr/>
          <p:nvPr/>
        </p:nvSpPr>
        <p:spPr>
          <a:xfrm>
            <a:off x="1798560" y="1413000"/>
            <a:ext cx="6176880" cy="955440"/>
          </a:xfrm>
          <a:custGeom>
            <a:avLst/>
            <a:gdLst/>
            <a:ahLst/>
            <a:rect l="l" t="t" r="r" b="b"/>
            <a:pathLst>
              <a:path w="3891" h="602">
                <a:moveTo>
                  <a:pt x="0" y="602"/>
                </a:moveTo>
                <a:lnTo>
                  <a:pt x="0" y="0"/>
                </a:lnTo>
                <a:lnTo>
                  <a:pt x="3891" y="0"/>
                </a:lnTo>
                <a:lnTo>
                  <a:pt x="3891" y="141"/>
                </a:lnTo>
              </a:path>
            </a:pathLst>
          </a:custGeom>
          <a:noFill/>
          <a:ln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8" name=""/>
          <p:cNvSpPr/>
          <p:nvPr/>
        </p:nvSpPr>
        <p:spPr>
          <a:xfrm>
            <a:off x="486360" y="119160"/>
            <a:ext cx="1181880" cy="305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Tahoma"/>
              </a:rPr>
              <a:t>Figure S1.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9" name=""/>
          <p:cNvSpPr/>
          <p:nvPr/>
        </p:nvSpPr>
        <p:spPr>
          <a:xfrm>
            <a:off x="2646000" y="2505240"/>
            <a:ext cx="315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spcBef>
                <a:spcPts val="67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0" name=""/>
          <p:cNvSpPr/>
          <p:nvPr/>
        </p:nvSpPr>
        <p:spPr>
          <a:xfrm>
            <a:off x="3729960" y="2430360"/>
            <a:ext cx="315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spcBef>
                <a:spcPts val="67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1" name=""/>
          <p:cNvSpPr/>
          <p:nvPr/>
        </p:nvSpPr>
        <p:spPr>
          <a:xfrm>
            <a:off x="4747680" y="2867040"/>
            <a:ext cx="315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spcBef>
                <a:spcPts val="67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2" name=""/>
          <p:cNvSpPr/>
          <p:nvPr/>
        </p:nvSpPr>
        <p:spPr>
          <a:xfrm>
            <a:off x="5822280" y="2550960"/>
            <a:ext cx="315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spcBef>
                <a:spcPts val="67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3" name=""/>
          <p:cNvSpPr/>
          <p:nvPr/>
        </p:nvSpPr>
        <p:spPr>
          <a:xfrm>
            <a:off x="6817680" y="2827440"/>
            <a:ext cx="315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spcBef>
                <a:spcPts val="67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38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9-08-06T09:40:40Z</dcterms:created>
  <dc:creator>HP Customer</dc:creator>
  <dc:description/>
  <dc:language>en-US</dc:language>
  <cp:lastModifiedBy>HP Customer</cp:lastModifiedBy>
  <dcterms:modified xsi:type="dcterms:W3CDTF">2010-02-18T00:33:34Z</dcterms:modified>
  <cp:revision>22</cp:revision>
  <dc:subject/>
  <dc:title>スライド 1</dc:title>
</cp:coreProperties>
</file>